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06957-EFDD-463F-A4E1-4688BB493F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526694-1D0D-4F4A-B754-3FB7D58296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1B903-ABF6-47C0-93A6-11D127DDB9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5AD81-14E1-4EF9-B4EF-77F1F8EF30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16372-DD8A-4D87-813E-86D14BC928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B8805-B7B8-4877-8185-5F8C9022C7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C7246-9AD3-43FC-A905-6EC4EAE082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D6B31-EE95-4B77-9431-FF5E9499EA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90749-346D-434F-883C-E6F120DF4D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8A25D7-0170-4A50-BF8E-31ECC3D89E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42AF2-83DB-470B-8909-288720D16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C0FDC-AE71-4F72-8C01-17445AE422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FD128E-65D9-43D3-970C-2FF3CFF41985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 3"/>
          <p:cNvSpPr/>
          <p:nvPr/>
        </p:nvSpPr>
        <p:spPr>
          <a:xfrm>
            <a:off x="357120" y="714240"/>
            <a:ext cx="214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642960" y="2143080"/>
          <a:ext cx="7786800" cy="2511360"/>
        </p:xfrm>
        <a:graphic>
          <a:graphicData uri="http://schemas.openxmlformats.org/drawingml/2006/table">
            <a:tbl>
              <a:tblPr/>
              <a:tblGrid>
                <a:gridCol w="1338480"/>
                <a:gridCol w="688320"/>
                <a:gridCol w="827280"/>
                <a:gridCol w="777240"/>
                <a:gridCol w="650160"/>
                <a:gridCol w="157680"/>
                <a:gridCol w="780480"/>
                <a:gridCol w="856080"/>
                <a:gridCol w="856080"/>
                <a:gridCol w="804240"/>
                <a:gridCol w="50760"/>
              </a:tblGrid>
              <a:tr h="313200"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pstream nucleo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60840" rIns="60840" tIns="6840" bIns="0" anchor="t">
                      <a:noAutofit/>
                    </a:bodyPr>
                    <a:p>
                      <a:pPr marL="23760" indent="-23760"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ownstream nucleosom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93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mmit position (St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F te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uzziness score (average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T te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mmit position (Std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F te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uzziness score (average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T test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4400">
                <a:tc>
                  <a:txBody>
                    <a:bodyPr lIns="60840" rIns="60840" tIns="684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nstitutive poly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.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.7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85e-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.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57e-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11760">
                <a:tc>
                  <a:txBody>
                    <a:bodyPr lIns="60840" rIns="60840" tIns="684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lternative poly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.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.3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3200">
                <a:tc>
                  <a:txBody>
                    <a:bodyPr lIns="60840" rIns="60840" tIns="684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stal poly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.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8e-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1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.4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8e -0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0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1760">
                <a:tc>
                  <a:txBody>
                    <a:bodyPr lIns="60840" rIns="60840" tIns="684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ximal poly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4.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1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t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5.7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0840" rIns="60840" tIns="6840" bIns="0" anchor="ctr">
                      <a:noAutofit/>
                    </a:bodyPr>
                    <a:p>
                      <a:pPr algn="ctr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0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0840" marR="60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just">
                        <a:lnSpc>
                          <a:spcPts val="18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zh-CN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26T01:38:50Z</dcterms:created>
  <dc:creator>huanghuan</dc:creator>
  <dc:description/>
  <dc:language>en-US</dc:language>
  <cp:lastModifiedBy>huanghuan</cp:lastModifiedBy>
  <dcterms:modified xsi:type="dcterms:W3CDTF">2013-11-20T06:15:13Z</dcterms:modified>
  <cp:revision>49</cp:revision>
  <dc:subject/>
  <dc:title>幻灯片 1</dc:title>
</cp:coreProperties>
</file>